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150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207E22-0E75-4F86-BA83-C6E350EDF241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052396-4CCC-4275-8BD6-5AE1E3F6A6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90106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978025" y="685800"/>
            <a:ext cx="29019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7704D8-5E53-4896-9C58-E2F263488CC0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34485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978025" y="685800"/>
            <a:ext cx="29019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7704D8-5E53-4896-9C58-E2F263488CC0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34485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978025" y="685800"/>
            <a:ext cx="29019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7704D8-5E53-4896-9C58-E2F263488CC0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34485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4-6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773188" y="166732"/>
            <a:ext cx="7889470" cy="6580058"/>
            <a:chOff x="773188" y="166732"/>
            <a:chExt cx="7889470" cy="6580058"/>
          </a:xfrm>
        </p:grpSpPr>
        <p:sp>
          <p:nvSpPr>
            <p:cNvPr id="3" name="TextBox 2"/>
            <p:cNvSpPr txBox="1"/>
            <p:nvPr/>
          </p:nvSpPr>
          <p:spPr>
            <a:xfrm>
              <a:off x="7126487" y="166732"/>
              <a:ext cx="153617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 smtClean="0"/>
                <a:t>Fig. S1</a:t>
              </a:r>
              <a:endParaRPr lang="en-US" sz="2800" b="1" dirty="0"/>
            </a:p>
          </p:txBody>
        </p:sp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3188" y="428342"/>
              <a:ext cx="6318448" cy="631844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938626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组合 11"/>
          <p:cNvGrpSpPr/>
          <p:nvPr/>
        </p:nvGrpSpPr>
        <p:grpSpPr>
          <a:xfrm>
            <a:off x="1739618" y="162642"/>
            <a:ext cx="7104857" cy="5251090"/>
            <a:chOff x="1739618" y="162642"/>
            <a:chExt cx="7104857" cy="525109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3587" y="2867025"/>
              <a:ext cx="5076825" cy="112395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995313" y="4028410"/>
              <a:ext cx="52629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M</a:t>
              </a:r>
              <a:r>
                <a:rPr lang="en-US" altLang="zh-CN" dirty="0" smtClean="0">
                  <a:latin typeface="Times New Roman" pitchFamily="18" charset="0"/>
                  <a:cs typeface="Times New Roman" pitchFamily="18" charset="0"/>
                </a:rPr>
                <a:t>     </a:t>
              </a:r>
              <a:r>
                <a:rPr lang="en-US" altLang="zh-CN" dirty="0" smtClean="0"/>
                <a:t>SR_1 SR_2 SR_3 SR_1 SR_2 SR_3 SR_1 SR_2 SR_3</a:t>
              </a:r>
              <a:endParaRPr lang="zh-CN" altLang="en-US" dirty="0"/>
            </a:p>
          </p:txBody>
        </p:sp>
        <p:cxnSp>
          <p:nvCxnSpPr>
            <p:cNvPr id="5" name="直接连接符 4"/>
            <p:cNvCxnSpPr/>
            <p:nvPr/>
          </p:nvCxnSpPr>
          <p:spPr>
            <a:xfrm>
              <a:off x="2555776" y="4397742"/>
              <a:ext cx="151216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接连接符 5"/>
            <p:cNvCxnSpPr/>
            <p:nvPr/>
          </p:nvCxnSpPr>
          <p:spPr>
            <a:xfrm>
              <a:off x="4067944" y="4528284"/>
              <a:ext cx="151216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连接符 6"/>
            <p:cNvCxnSpPr/>
            <p:nvPr/>
          </p:nvCxnSpPr>
          <p:spPr>
            <a:xfrm>
              <a:off x="5694647" y="4397742"/>
              <a:ext cx="151216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2745532" y="4528284"/>
              <a:ext cx="6912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SSR 1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330944" y="4675068"/>
              <a:ext cx="6912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SSR 2</a:t>
              </a:r>
              <a:endParaRPr lang="zh-CN" alt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05123" y="4528284"/>
              <a:ext cx="6912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SSR 3</a:t>
              </a:r>
              <a:endParaRPr lang="zh-CN" altLang="en-US" dirty="0"/>
            </a:p>
          </p:txBody>
        </p:sp>
        <p:sp>
          <p:nvSpPr>
            <p:cNvPr id="4" name="矩形 3"/>
            <p:cNvSpPr/>
            <p:nvPr/>
          </p:nvSpPr>
          <p:spPr>
            <a:xfrm>
              <a:off x="1739618" y="5044400"/>
              <a:ext cx="6565082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Polymorphism of the </a:t>
              </a:r>
              <a:r>
                <a:rPr lang="en-US" altLang="zh-CN" b="1" dirty="0" smtClean="0"/>
                <a:t>primers (SSR1-3) </a:t>
              </a:r>
              <a:r>
                <a:rPr lang="en-US" altLang="zh-CN" b="1" dirty="0"/>
                <a:t>in </a:t>
              </a:r>
              <a:r>
                <a:rPr lang="en-US" altLang="zh-CN" b="1" dirty="0" smtClean="0"/>
                <a:t>3 </a:t>
              </a:r>
              <a:r>
                <a:rPr lang="en-US" altLang="zh-CN" b="1" i="1" dirty="0" smtClean="0"/>
                <a:t>Stevia</a:t>
              </a:r>
              <a:r>
                <a:rPr lang="en-US" altLang="zh-CN" b="1" dirty="0" smtClean="0"/>
                <a:t> </a:t>
              </a:r>
              <a:r>
                <a:rPr lang="en-US" altLang="zh-CN" b="1" dirty="0" err="1"/>
                <a:t>genetypes</a:t>
              </a:r>
              <a:r>
                <a:rPr lang="en-US" altLang="zh-CN" b="1" dirty="0"/>
                <a:t>.</a:t>
              </a:r>
              <a:endParaRPr lang="zh-CN" alt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308304" y="162642"/>
              <a:ext cx="153617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 smtClean="0"/>
                <a:t>Fig. S2</a:t>
              </a:r>
              <a:endParaRPr lang="en-US" sz="2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40121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组合 11"/>
          <p:cNvGrpSpPr/>
          <p:nvPr/>
        </p:nvGrpSpPr>
        <p:grpSpPr>
          <a:xfrm>
            <a:off x="1644790" y="138835"/>
            <a:ext cx="4079338" cy="6719167"/>
            <a:chOff x="1594545" y="-894110"/>
            <a:chExt cx="5425727" cy="10083750"/>
          </a:xfrm>
        </p:grpSpPr>
        <p:grpSp>
          <p:nvGrpSpPr>
            <p:cNvPr id="2" name="组合 1"/>
            <p:cNvGrpSpPr/>
            <p:nvPr/>
          </p:nvGrpSpPr>
          <p:grpSpPr>
            <a:xfrm>
              <a:off x="1797021" y="-894110"/>
              <a:ext cx="5223251" cy="3187573"/>
              <a:chOff x="1327943" y="635496"/>
              <a:chExt cx="7458024" cy="2347512"/>
            </a:xfrm>
          </p:grpSpPr>
          <p:pic>
            <p:nvPicPr>
              <p:cNvPr id="3" name="Picture 2" descr="C:\Users\PENG\Desktop\20131118-回复(1)\KEGG_result\SR_1\SR_1.top0.02_enriched_KEGG_pathway_scatterplot.pn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27945" y="635496"/>
                <a:ext cx="7458022" cy="234751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327943" y="1330272"/>
                <a:ext cx="48005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A</a:t>
                </a:r>
              </a:p>
            </p:txBody>
          </p:sp>
        </p:grpSp>
        <p:grpSp>
          <p:nvGrpSpPr>
            <p:cNvPr id="5" name="组合 4"/>
            <p:cNvGrpSpPr/>
            <p:nvPr/>
          </p:nvGrpSpPr>
          <p:grpSpPr>
            <a:xfrm>
              <a:off x="1695570" y="2280340"/>
              <a:ext cx="5324702" cy="3192439"/>
              <a:chOff x="751136" y="2453978"/>
              <a:chExt cx="7951448" cy="1910820"/>
            </a:xfrm>
          </p:grpSpPr>
          <p:pic>
            <p:nvPicPr>
              <p:cNvPr id="6" name="Picture 3" descr="C:\Users\PENG\Desktop\20131118-回复(1)\KEGG_result\SR_2\SR_2.top0.02_enriched_KEGG_pathway_scatterplot.pn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02634" y="2453978"/>
                <a:ext cx="7799950" cy="191082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751136" y="2503865"/>
                <a:ext cx="805053" cy="2763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 smtClean="0"/>
                  <a:t>B</a:t>
                </a:r>
                <a:endParaRPr lang="en-US" sz="2400" b="1" dirty="0"/>
              </a:p>
            </p:txBody>
          </p:sp>
        </p:grpSp>
        <p:grpSp>
          <p:nvGrpSpPr>
            <p:cNvPr id="8" name="组合 7"/>
            <p:cNvGrpSpPr/>
            <p:nvPr/>
          </p:nvGrpSpPr>
          <p:grpSpPr>
            <a:xfrm>
              <a:off x="1594545" y="5437742"/>
              <a:ext cx="5425727" cy="3751898"/>
              <a:chOff x="-345968" y="4504494"/>
              <a:chExt cx="9270859" cy="1732818"/>
            </a:xfrm>
          </p:grpSpPr>
          <p:pic>
            <p:nvPicPr>
              <p:cNvPr id="9" name="Picture 4" descr="C:\Users\PENG\Desktop\20131118-回复(1)\KEGG_result\SR_3\SR_3.top0.02_enriched_KEGG_pathway_scatterplot.pn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4513920"/>
                <a:ext cx="8924891" cy="172339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-345968" y="4504494"/>
                <a:ext cx="920439" cy="21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 smtClean="0"/>
                  <a:t>C</a:t>
                </a:r>
                <a:endParaRPr lang="en-US" sz="2400" b="1" dirty="0"/>
              </a:p>
            </p:txBody>
          </p:sp>
        </p:grpSp>
      </p:grpSp>
      <p:sp>
        <p:nvSpPr>
          <p:cNvPr id="11" name="TextBox 10"/>
          <p:cNvSpPr txBox="1"/>
          <p:nvPr/>
        </p:nvSpPr>
        <p:spPr>
          <a:xfrm>
            <a:off x="7308304" y="162642"/>
            <a:ext cx="15361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 smtClean="0"/>
              <a:t>Fig. </a:t>
            </a:r>
            <a:r>
              <a:rPr lang="en-US" sz="2800" b="1" smtClean="0"/>
              <a:t>S3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14890307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/>
          <p:cNvGrpSpPr/>
          <p:nvPr/>
        </p:nvGrpSpPr>
        <p:grpSpPr>
          <a:xfrm>
            <a:off x="539552" y="289035"/>
            <a:ext cx="8604448" cy="6594794"/>
            <a:chOff x="1261083" y="252115"/>
            <a:chExt cx="7213044" cy="12349460"/>
          </a:xfrm>
        </p:grpSpPr>
        <p:sp>
          <p:nvSpPr>
            <p:cNvPr id="32" name="TextBox 31"/>
            <p:cNvSpPr txBox="1"/>
            <p:nvPr/>
          </p:nvSpPr>
          <p:spPr>
            <a:xfrm>
              <a:off x="6660232" y="396132"/>
              <a:ext cx="1813895" cy="9797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 smtClean="0"/>
                <a:t>Fig. S</a:t>
              </a:r>
              <a:r>
                <a:rPr lang="en-US" altLang="zh-CN" sz="2800" b="1" dirty="0" smtClean="0"/>
                <a:t>4</a:t>
              </a:r>
              <a:endParaRPr lang="en-US" sz="2800" b="1" dirty="0"/>
            </a:p>
          </p:txBody>
        </p:sp>
        <p:grpSp>
          <p:nvGrpSpPr>
            <p:cNvPr id="33" name="组合 32"/>
            <p:cNvGrpSpPr/>
            <p:nvPr/>
          </p:nvGrpSpPr>
          <p:grpSpPr>
            <a:xfrm>
              <a:off x="1261083" y="252115"/>
              <a:ext cx="5202894" cy="12349460"/>
              <a:chOff x="755576" y="-963488"/>
              <a:chExt cx="6912768" cy="10346034"/>
            </a:xfrm>
          </p:grpSpPr>
          <p:grpSp>
            <p:nvGrpSpPr>
              <p:cNvPr id="34" name="组合 33"/>
              <p:cNvGrpSpPr/>
              <p:nvPr/>
            </p:nvGrpSpPr>
            <p:grpSpPr>
              <a:xfrm>
                <a:off x="755576" y="5877272"/>
                <a:ext cx="6788696" cy="3505274"/>
                <a:chOff x="-1565013" y="5965210"/>
                <a:chExt cx="10529501" cy="2288326"/>
              </a:xfrm>
            </p:grpSpPr>
            <p:pic>
              <p:nvPicPr>
                <p:cNvPr id="41" name="Picture 4" descr="C:\Users\PENG\Desktop\20131118-回复(1)\GO_result\SR_3\SR_3.top0.02_Enriched_GO_classification.png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-1565011" y="5965210"/>
                  <a:ext cx="10529499" cy="228832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2" name="TextBox 41"/>
                <p:cNvSpPr txBox="1"/>
                <p:nvPr/>
              </p:nvSpPr>
              <p:spPr>
                <a:xfrm>
                  <a:off x="-1565013" y="6875361"/>
                  <a:ext cx="643661" cy="4728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400" b="1" dirty="0" smtClean="0"/>
                    <a:t>C</a:t>
                  </a:r>
                  <a:endParaRPr lang="en-US" sz="2400" b="1" dirty="0"/>
                </a:p>
              </p:txBody>
            </p:sp>
          </p:grpSp>
          <p:grpSp>
            <p:nvGrpSpPr>
              <p:cNvPr id="35" name="组合 34"/>
              <p:cNvGrpSpPr/>
              <p:nvPr/>
            </p:nvGrpSpPr>
            <p:grpSpPr>
              <a:xfrm>
                <a:off x="827584" y="2444006"/>
                <a:ext cx="6840760" cy="3505274"/>
                <a:chOff x="-1620688" y="3338372"/>
                <a:chExt cx="10585176" cy="2385952"/>
              </a:xfrm>
            </p:grpSpPr>
            <p:pic>
              <p:nvPicPr>
                <p:cNvPr id="39" name="Picture 3" descr="C:\Users\PENG\Desktop\20131118-回复(1)\GO_result\SR_2\SR_2.top0.02_Enriched_GO_classification.png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-1620688" y="3338372"/>
                  <a:ext cx="10585176" cy="238595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0" name="TextBox 39"/>
                <p:cNvSpPr txBox="1"/>
                <p:nvPr/>
              </p:nvSpPr>
              <p:spPr>
                <a:xfrm>
                  <a:off x="-1565012" y="4200129"/>
                  <a:ext cx="643664" cy="4929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400" b="1" dirty="0" smtClean="0"/>
                    <a:t>B</a:t>
                  </a:r>
                  <a:endParaRPr lang="en-US" sz="2400" b="1" dirty="0"/>
                </a:p>
              </p:txBody>
            </p:sp>
          </p:grpSp>
          <p:grpSp>
            <p:nvGrpSpPr>
              <p:cNvPr id="36" name="组合 35"/>
              <p:cNvGrpSpPr/>
              <p:nvPr/>
            </p:nvGrpSpPr>
            <p:grpSpPr>
              <a:xfrm>
                <a:off x="827584" y="-963488"/>
                <a:ext cx="6840760" cy="3505274"/>
                <a:chOff x="-1620688" y="-320715"/>
                <a:chExt cx="11173241" cy="2480507"/>
              </a:xfrm>
            </p:grpSpPr>
            <p:pic>
              <p:nvPicPr>
                <p:cNvPr id="37" name="Picture 2" descr="C:\Users\PENG\Desktop\20131118-回复(1)\GO_result\SR_1\SR_1.top0.02_Enriched_GO_classification.png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-1620688" y="-320715"/>
                  <a:ext cx="11173241" cy="24805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8" name="TextBox 37"/>
                <p:cNvSpPr txBox="1"/>
                <p:nvPr/>
              </p:nvSpPr>
              <p:spPr>
                <a:xfrm>
                  <a:off x="-1535650" y="710512"/>
                  <a:ext cx="643663" cy="5125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400" b="1" dirty="0"/>
                    <a:t>A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6821208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1014211" y="373811"/>
            <a:ext cx="6974298" cy="6108985"/>
            <a:chOff x="392604" y="153283"/>
            <a:chExt cx="7319962" cy="10359960"/>
          </a:xfrm>
        </p:grpSpPr>
        <p:sp>
          <p:nvSpPr>
            <p:cNvPr id="3" name="TextBox 2"/>
            <p:cNvSpPr txBox="1"/>
            <p:nvPr/>
          </p:nvSpPr>
          <p:spPr>
            <a:xfrm>
              <a:off x="6176395" y="153283"/>
              <a:ext cx="1536171" cy="887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b="1" dirty="0" smtClean="0"/>
                <a:t>Fig. S</a:t>
              </a:r>
              <a:r>
                <a:rPr lang="en-US" altLang="zh-CN" sz="2800" b="1" dirty="0" smtClean="0"/>
                <a:t>5</a:t>
              </a:r>
              <a:endParaRPr lang="en-US" sz="2800" b="1" dirty="0"/>
            </a:p>
          </p:txBody>
        </p:sp>
        <p:grpSp>
          <p:nvGrpSpPr>
            <p:cNvPr id="2" name="组合 1"/>
            <p:cNvGrpSpPr/>
            <p:nvPr/>
          </p:nvGrpSpPr>
          <p:grpSpPr>
            <a:xfrm>
              <a:off x="392604" y="255500"/>
              <a:ext cx="5979596" cy="10257743"/>
              <a:chOff x="-271077" y="-1759339"/>
              <a:chExt cx="7795405" cy="25620543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-1759339"/>
                <a:ext cx="7493173" cy="884746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-271077" y="386274"/>
                <a:ext cx="991104" cy="22162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2800" b="1" dirty="0" smtClean="0"/>
                  <a:t>A</a:t>
                </a:r>
                <a:endParaRPr lang="en-US" sz="2800" b="1" dirty="0"/>
              </a:p>
            </p:txBody>
          </p:sp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31907" y="15235125"/>
                <a:ext cx="7556235" cy="862607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3" name="Picture 5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5" y="6703290"/>
                <a:ext cx="7510188" cy="886755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-40043" y="8659454"/>
                <a:ext cx="529037" cy="22162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2800" b="1" dirty="0" smtClean="0"/>
                  <a:t>B</a:t>
                </a:r>
                <a:endParaRPr lang="zh-CN" altLang="en-US" sz="2800" b="1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-132327" y="17614325"/>
                <a:ext cx="746179" cy="22162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zh-CN" altLang="en-US" sz="2800" b="1" dirty="0"/>
                  <a:t>Ｃ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177533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914703" y="1"/>
            <a:ext cx="8229298" cy="6690278"/>
            <a:chOff x="914703" y="0"/>
            <a:chExt cx="8229298" cy="15707645"/>
          </a:xfrm>
        </p:grpSpPr>
        <p:sp>
          <p:nvSpPr>
            <p:cNvPr id="12" name="TextBox 11"/>
            <p:cNvSpPr txBox="1"/>
            <p:nvPr/>
          </p:nvSpPr>
          <p:spPr>
            <a:xfrm>
              <a:off x="7607830" y="0"/>
              <a:ext cx="1536171" cy="1228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 smtClean="0"/>
                <a:t>Fig. S</a:t>
              </a:r>
              <a:r>
                <a:rPr lang="en-US" altLang="zh-CN" sz="2800" b="1" dirty="0" smtClean="0"/>
                <a:t>6</a:t>
              </a:r>
              <a:endParaRPr lang="en-US" sz="2800" b="1" dirty="0"/>
            </a:p>
          </p:txBody>
        </p:sp>
        <p:grpSp>
          <p:nvGrpSpPr>
            <p:cNvPr id="13" name="组合 12"/>
            <p:cNvGrpSpPr/>
            <p:nvPr/>
          </p:nvGrpSpPr>
          <p:grpSpPr>
            <a:xfrm>
              <a:off x="914703" y="261610"/>
              <a:ext cx="6492214" cy="15446035"/>
              <a:chOff x="0" y="-10378774"/>
              <a:chExt cx="8224839" cy="43377304"/>
            </a:xfrm>
          </p:grpSpPr>
          <p:pic>
            <p:nvPicPr>
              <p:cNvPr id="14" name="Picture 3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-10378774"/>
                <a:ext cx="8224838" cy="1456705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5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" y="3903299"/>
                <a:ext cx="8224837" cy="1474508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6" name="Picture 5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18478267"/>
                <a:ext cx="8224838" cy="145202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384045" y="-5687076"/>
                <a:ext cx="768085" cy="34498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 smtClean="0"/>
                  <a:t>A</a:t>
                </a:r>
                <a:endParaRPr lang="en-US" sz="28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08822" y="7918031"/>
                <a:ext cx="768085" cy="34498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 smtClean="0"/>
                  <a:t>B</a:t>
                </a:r>
                <a:endParaRPr lang="en-US" sz="28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79219" y="24627584"/>
                <a:ext cx="768085" cy="34498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 smtClean="0"/>
                  <a:t>C</a:t>
                </a:r>
                <a:endParaRPr lang="en-US" sz="28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955329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2230467" y="69754"/>
            <a:ext cx="6027215" cy="6675927"/>
            <a:chOff x="2635443" y="-45671"/>
            <a:chExt cx="6027215" cy="6675927"/>
          </a:xfrm>
        </p:grpSpPr>
        <p:pic>
          <p:nvPicPr>
            <p:cNvPr id="1026" name="Picture 2" descr="C:\Users\PENG\Desktop\cjw\Hcluster_heatmap.detail(2).pn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35443" y="-45671"/>
              <a:ext cx="3955760" cy="667592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3515883" y="188640"/>
              <a:ext cx="1728192" cy="27003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/>
            <p:cNvSpPr/>
            <p:nvPr/>
          </p:nvSpPr>
          <p:spPr>
            <a:xfrm>
              <a:off x="3502157" y="2888940"/>
              <a:ext cx="1728192" cy="3741316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939819" y="1269367"/>
              <a:ext cx="96010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 smtClean="0"/>
                <a:t>A</a:t>
              </a:r>
              <a:endParaRPr lang="en-US" sz="28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939819" y="4332729"/>
              <a:ext cx="96010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 smtClean="0"/>
                <a:t>B</a:t>
              </a:r>
              <a:endParaRPr lang="en-US" sz="28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126487" y="166732"/>
              <a:ext cx="153617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 smtClean="0"/>
                <a:t>Fig. S</a:t>
              </a:r>
              <a:r>
                <a:rPr lang="en-US" altLang="zh-CN" sz="2800" b="1" dirty="0"/>
                <a:t>7</a:t>
              </a:r>
              <a:endParaRPr lang="en-US" sz="2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894773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66</Words>
  <Application>Microsoft Office PowerPoint</Application>
  <PresentationFormat>全屏显示(4:3)</PresentationFormat>
  <Paragraphs>29</Paragraphs>
  <Slides>7</Slides>
  <Notes>3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king</cp:lastModifiedBy>
  <cp:revision>1</cp:revision>
  <dcterms:modified xsi:type="dcterms:W3CDTF">2014-06-04T10:33:55Z</dcterms:modified>
</cp:coreProperties>
</file>